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737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989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979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649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725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638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074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361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465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694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662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8DE80-7CA8-4B8B-A791-212A5B7DE63E}" type="datetimeFigureOut">
              <a:rPr lang="en-US" smtClean="0"/>
              <a:t>10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972AF5-5834-4D74-B2DB-8C27221EB2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98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68"/>
          <a:stretch/>
        </p:blipFill>
        <p:spPr>
          <a:xfrm>
            <a:off x="1233551" y="43137"/>
            <a:ext cx="9371896" cy="643805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136251" y="6481189"/>
            <a:ext cx="10561164" cy="3088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05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.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Cluster representation of </a:t>
            </a:r>
            <a:r>
              <a:rPr lang="en-US" sz="1050" i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. napus 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YS), GM </a:t>
            </a:r>
            <a:r>
              <a:rPr lang="en-US" sz="1050" i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. napus 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TG), </a:t>
            </a:r>
            <a:r>
              <a:rPr lang="en-US" sz="1050" i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. rapa 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sp. </a:t>
            </a:r>
            <a:r>
              <a:rPr lang="en-US" sz="1050" i="1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ekinensis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</a:t>
            </a:r>
            <a:r>
              <a:rPr lang="en-US" sz="1050" i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. rapa 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1 hybrid, </a:t>
            </a:r>
            <a:r>
              <a:rPr lang="en-US" sz="1050" i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. rapa 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sp. </a:t>
            </a:r>
            <a:r>
              <a:rPr lang="en-US" sz="1050" i="1" dirty="0" err="1">
                <a:latin typeface="Times New Roman" panose="02020603050405020304" pitchFamily="18" charset="0"/>
                <a:ea typeface="맑은 고딕" panose="020B0503020000020004" pitchFamily="50" charset="-127"/>
              </a:rPr>
              <a:t>pekinensis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BC1) with 10 agricultural characteristics.</a:t>
            </a:r>
            <a:endParaRPr lang="en-US" sz="105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3513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1347" y="139798"/>
            <a:ext cx="7802765" cy="6344421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387081" y="6218523"/>
            <a:ext cx="6765545" cy="3347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05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2.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Two dimensional PCA showing the contribution and relationships among the ten morphological characteristics.</a:t>
            </a:r>
            <a:endParaRPr lang="en-US" sz="105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62472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440180" y="1242204"/>
            <a:ext cx="11379251" cy="3040131"/>
            <a:chOff x="440180" y="1242204"/>
            <a:chExt cx="11379251" cy="304013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94" t="21635" r="7513" b="27547"/>
            <a:stretch/>
          </p:blipFill>
          <p:spPr>
            <a:xfrm>
              <a:off x="448578" y="1254463"/>
              <a:ext cx="3762357" cy="3027872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02" t="27296" r="15059" b="36729"/>
            <a:stretch/>
          </p:blipFill>
          <p:spPr>
            <a:xfrm>
              <a:off x="8057074" y="1242204"/>
              <a:ext cx="3762357" cy="3027872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75" t="12327" r="7009" b="37862"/>
            <a:stretch/>
          </p:blipFill>
          <p:spPr>
            <a:xfrm>
              <a:off x="4245439" y="1242205"/>
              <a:ext cx="3777131" cy="3040130"/>
            </a:xfrm>
            <a:prstGeom prst="rect">
              <a:avLst/>
            </a:prstGeom>
          </p:spPr>
        </p:pic>
        <p:sp>
          <p:nvSpPr>
            <p:cNvPr id="9" name="Oval 8"/>
            <p:cNvSpPr/>
            <p:nvPr/>
          </p:nvSpPr>
          <p:spPr>
            <a:xfrm>
              <a:off x="440180" y="1242204"/>
              <a:ext cx="224287" cy="250166"/>
            </a:xfrm>
            <a:prstGeom prst="ellipse">
              <a:avLst/>
            </a:prstGeom>
            <a:solidFill>
              <a:schemeClr val="bg1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>
                  <a:solidFill>
                    <a:schemeClr val="tx1"/>
                  </a:solidFill>
                </a:rPr>
                <a:t>A</a:t>
              </a:r>
              <a:endParaRPr lang="en-US" sz="1600" dirty="0">
                <a:solidFill>
                  <a:schemeClr val="tx1"/>
                </a:solidFill>
              </a:endParaRPr>
            </a:p>
          </p:txBody>
        </p:sp>
        <p:sp>
          <p:nvSpPr>
            <p:cNvPr id="10" name="Oval 9"/>
            <p:cNvSpPr/>
            <p:nvPr/>
          </p:nvSpPr>
          <p:spPr>
            <a:xfrm>
              <a:off x="4251815" y="1242204"/>
              <a:ext cx="224287" cy="250166"/>
            </a:xfrm>
            <a:prstGeom prst="ellipse">
              <a:avLst/>
            </a:prstGeom>
            <a:solidFill>
              <a:schemeClr val="bg1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>
                  <a:solidFill>
                    <a:schemeClr val="tx1"/>
                  </a:solidFill>
                </a:rPr>
                <a:t>B</a:t>
              </a:r>
              <a:endParaRPr lang="en-US" sz="1600" dirty="0">
                <a:solidFill>
                  <a:schemeClr val="tx1"/>
                </a:solidFill>
              </a:endParaRPr>
            </a:p>
          </p:txBody>
        </p:sp>
        <p:sp>
          <p:nvSpPr>
            <p:cNvPr id="11" name="Oval 10"/>
            <p:cNvSpPr/>
            <p:nvPr/>
          </p:nvSpPr>
          <p:spPr>
            <a:xfrm>
              <a:off x="8057074" y="1242204"/>
              <a:ext cx="224287" cy="250166"/>
            </a:xfrm>
            <a:prstGeom prst="ellipse">
              <a:avLst/>
            </a:prstGeom>
            <a:solidFill>
              <a:schemeClr val="bg1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>
                  <a:solidFill>
                    <a:schemeClr val="tx1"/>
                  </a:solidFill>
                </a:rPr>
                <a:t>C</a:t>
              </a:r>
              <a:endParaRPr lang="en-US" sz="1600" dirty="0">
                <a:solidFill>
                  <a:schemeClr val="tx1"/>
                </a:solidFill>
              </a:endParaRPr>
            </a:p>
          </p:txBody>
        </p:sp>
      </p:grpSp>
      <p:sp>
        <p:nvSpPr>
          <p:cNvPr id="12" name="Rectangle 11"/>
          <p:cNvSpPr/>
          <p:nvPr/>
        </p:nvSpPr>
        <p:spPr>
          <a:xfrm>
            <a:off x="2329756" y="4898681"/>
            <a:ext cx="6765545" cy="577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05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</a:t>
            </a:r>
            <a:r>
              <a:rPr lang="en-US" sz="105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3.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sz="105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mmunostrip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specific to bar protein results for backcross progenies. A – BC1 progenies, </a:t>
            </a:r>
            <a:r>
              <a:rPr lang="en-US" sz="105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 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– BC2 </a:t>
            </a:r>
            <a:r>
              <a:rPr lang="en-US" sz="105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ogenies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C – BC3 </a:t>
            </a:r>
            <a:r>
              <a:rPr lang="en-US" sz="105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ogenies,</a:t>
            </a:r>
            <a:r>
              <a:rPr lang="en-US" sz="105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endParaRPr lang="en-US" sz="105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070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94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dian</dc:creator>
  <cp:lastModifiedBy>Pandian</cp:lastModifiedBy>
  <cp:revision>14</cp:revision>
  <dcterms:created xsi:type="dcterms:W3CDTF">2024-01-02T00:32:13Z</dcterms:created>
  <dcterms:modified xsi:type="dcterms:W3CDTF">2024-10-05T06:25:15Z</dcterms:modified>
</cp:coreProperties>
</file>